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119813" cy="8999538"/>
  <p:notesSz cx="7315200" cy="96012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19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8884"/>
    <a:srgbClr val="2878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 autoAdjust="0"/>
    <p:restoredTop sz="97340" autoAdjust="0"/>
  </p:normalViewPr>
  <p:slideViewPr>
    <p:cSldViewPr snapToGrid="0" showGuides="1">
      <p:cViewPr>
        <p:scale>
          <a:sx n="125" d="100"/>
          <a:sy n="125" d="100"/>
        </p:scale>
        <p:origin x="4312" y="20"/>
      </p:cViewPr>
      <p:guideLst>
        <p:guide orient="horz" pos="2835"/>
        <p:guide pos="195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170138" cy="4810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143427" y="1"/>
            <a:ext cx="3170138" cy="4810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3C58B8-C101-4551-87AB-182900D3AD51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55875" y="1200150"/>
            <a:ext cx="2203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31194" y="4621146"/>
            <a:ext cx="5852814" cy="377971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9120172"/>
            <a:ext cx="3170138" cy="481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143427" y="9120172"/>
            <a:ext cx="3170138" cy="481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F740E7-43D4-4289-948D-6A236230A6B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7329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58DFC3-3D19-4800-823F-C1703B1F60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64977" y="1472842"/>
            <a:ext cx="458986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A76AEB9-C542-4E14-92F8-9B5414FBE5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64977" y="4726842"/>
            <a:ext cx="458986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591045-AED6-415B-B88E-2496D082D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0B891D-72F4-47A5-B0E5-FE6752B9B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B81D92-F9C0-465A-AC37-E97D51FF6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288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D2B775-258D-4E5E-842E-E039A7CCE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D41A2EC-1C5F-46DA-8DBD-394AB50442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F8684D-B014-47FE-86F4-37A4DB982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C9E8EE-2469-4267-8B1D-88E1C8C7D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82F656-5655-490B-8D08-1AC8C20F5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773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8511AEA-E3BE-4C92-AAD8-4C6198CB2D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379491" y="479142"/>
            <a:ext cx="131958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3CB83F-9A8C-4715-BEE1-CFBF47620E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20737" y="479142"/>
            <a:ext cx="3882256" cy="7626692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310DF4-BDA2-4700-84EB-CF8DE0A79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C2F6EF-5E0A-4568-B379-2B311D657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FE45DB-2507-41DA-9E9D-EE49ED7B8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871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8D9220-2E30-49BB-A7D7-07A55DD33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85EBBC-0305-437B-A0A3-03BC26843D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7F8D74-3E4B-4E8C-A017-5F0FBE179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39BDA9-AF62-4CB3-9791-3370B6000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3636DE-7C02-4870-9FDF-FA26779E9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2466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8E0A23-5CFE-4AAB-9F46-39EAC8079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7550" y="2243636"/>
            <a:ext cx="5278339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91E434-80EF-41FC-A824-31892BAA4A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17550" y="6022609"/>
            <a:ext cx="5278339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B96147-746E-40F6-B433-52D6E07A1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5C668E-2219-4688-AFE7-87F42180E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585096-4DE1-4B38-B8EA-A4A317D7A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08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226041-AA38-4E44-A8F0-5AE12EE44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9DABDE-FA8B-4980-9B65-B4E32A4BAE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20737" y="2395710"/>
            <a:ext cx="2600921" cy="571012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03AF230-8765-4F9A-8D0A-9F583B19E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098155" y="2395710"/>
            <a:ext cx="2600921" cy="571012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3CEF8A-F401-4530-83A7-282E1A367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BA3D31-87D5-4DBA-8A95-2F29E5F4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AEE0C7-F616-4763-AF96-5F3AB80EF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118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08555C-FD95-4F0C-A0BE-598779531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479143"/>
            <a:ext cx="5278339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C3E3950-E37A-4054-850D-89B0C0EA56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1534" y="2206137"/>
            <a:ext cx="258896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4AB063-58D7-4480-8120-7CD2B98492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1534" y="3287331"/>
            <a:ext cx="2588968" cy="483516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DECB199-1AB9-4714-AEA6-E01D7C1D7B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098155" y="2206137"/>
            <a:ext cx="260171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2913D16-D5F1-4741-96F4-8EF0A44E98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098155" y="3287331"/>
            <a:ext cx="2601718" cy="483516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F67A28D-AD8E-41DD-B4C1-C17E461E3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4C431CC-7B23-4854-A85D-FB943609D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9152067-BA79-45F9-980F-8066AB699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2927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00BF7C-9BFC-4D3F-BD0C-D6487FEFE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F5E1438-7638-493D-A65A-873F5FF12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7BC0276-0ECC-456E-BE4B-E93525E89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AF62212-1778-4CBD-B4D6-17357C5D7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434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896A3DE-61D5-4935-AC65-5D719D06C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BF550BE-1BFE-4185-8EC4-7E9550194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0A43FF4-9117-41A1-AE8A-9245F0DEB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6981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617D23-A0A3-400E-AEB8-1ED2E625DF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99969"/>
            <a:ext cx="1973799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456250-A7A5-4F31-97E3-13AEC01F7D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01718" y="1295767"/>
            <a:ext cx="3098155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DF8DA3B-C5A7-4F59-B4E3-0815A56915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699862"/>
            <a:ext cx="1973799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679997-CE04-456A-9E00-9D9A757F5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8D898B-951E-4DBF-9249-DD2FC822D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DB4519-79AB-41C1-ACAF-320D299EA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10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098157-DE97-4902-BCF6-66E4AB7F7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99969"/>
            <a:ext cx="1973799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ACB1D18-4420-4E12-A2F4-C157895B38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601718" y="1295767"/>
            <a:ext cx="3098155" cy="6395505"/>
          </a:xfrm>
        </p:spPr>
        <p:txBody>
          <a:bodyPr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88720EA-4F65-4343-81AC-CFE0C094E9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699862"/>
            <a:ext cx="1973799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39A4D9-7096-44BA-9DAB-A3E624787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8FEBD7-5A88-4A2C-ABEF-52308141B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EBACCE7-864A-4646-808F-7FCA02500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0374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95A6308-68F2-4101-A418-49066E57F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737" y="479143"/>
            <a:ext cx="5278339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4F1F52-07A6-4823-A5C5-C5EDF406B4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0737" y="2395710"/>
            <a:ext cx="5278339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D04A29-100E-46D8-98E8-8F90C182E7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20737" y="8341239"/>
            <a:ext cx="137695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51A2C-44E1-455E-A5C2-26A03D89726A}" type="datetimeFigureOut">
              <a:rPr lang="zh-CN" altLang="en-US" smtClean="0"/>
              <a:t>2024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4C711D-2E36-49B4-969D-12571CE1D8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027188" y="8341239"/>
            <a:ext cx="206543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CC8FEF-4E29-44F7-B2AA-AAADD4911A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322118" y="8341239"/>
            <a:ext cx="137695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FA989-BCF9-41D7-AC59-A2FC4DDDA4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4321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1" name="对象 130">
            <a:extLst>
              <a:ext uri="{FF2B5EF4-FFF2-40B4-BE49-F238E27FC236}">
                <a16:creationId xmlns:a16="http://schemas.microsoft.com/office/drawing/2014/main" id="{3A362CE5-C135-46B8-8663-AADEF1D27D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8965112"/>
              </p:ext>
            </p:extLst>
          </p:nvPr>
        </p:nvGraphicFramePr>
        <p:xfrm>
          <a:off x="608534" y="4884518"/>
          <a:ext cx="591696" cy="11580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0" r:id="rId3" imgW="2958480" imgH="5790240" progId="">
                  <p:embed/>
                </p:oleObj>
              </mc:Choice>
              <mc:Fallback>
                <p:oleObj r:id="rId3" imgW="2958480" imgH="5790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8534" y="4884518"/>
                        <a:ext cx="591696" cy="11580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D211BAF7-2ACE-4C1D-90DA-5FAACD9405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5810513"/>
              </p:ext>
            </p:extLst>
          </p:nvPr>
        </p:nvGraphicFramePr>
        <p:xfrm>
          <a:off x="554528" y="1158413"/>
          <a:ext cx="1542834" cy="9180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1" r:id="rId5" imgW="10285560" imgH="6120360" progId="">
                  <p:embed/>
                </p:oleObj>
              </mc:Choice>
              <mc:Fallback>
                <p:oleObj r:id="rId5" imgW="10285560" imgH="61203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554528" y="1158413"/>
                        <a:ext cx="1542834" cy="9180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81B3C925-9371-4642-B99B-61E0757E1866}"/>
              </a:ext>
            </a:extLst>
          </p:cNvPr>
          <p:cNvSpPr txBox="1"/>
          <p:nvPr/>
        </p:nvSpPr>
        <p:spPr>
          <a:xfrm>
            <a:off x="2154360" y="2198740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54C20F9-90BD-4883-83D1-33C211DD7FBA}"/>
              </a:ext>
            </a:extLst>
          </p:cNvPr>
          <p:cNvSpPr txBox="1"/>
          <p:nvPr/>
        </p:nvSpPr>
        <p:spPr>
          <a:xfrm>
            <a:off x="2049609" y="1634374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573381DA-3FEB-4250-AD47-E2046385FA8E}"/>
              </a:ext>
            </a:extLst>
          </p:cNvPr>
          <p:cNvSpPr/>
          <p:nvPr/>
        </p:nvSpPr>
        <p:spPr>
          <a:xfrm>
            <a:off x="733915" y="1566400"/>
            <a:ext cx="1226483" cy="304800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699F8A58-D1A5-4C5F-97B4-CE697EA01BE9}"/>
              </a:ext>
            </a:extLst>
          </p:cNvPr>
          <p:cNvGrpSpPr/>
          <p:nvPr/>
        </p:nvGrpSpPr>
        <p:grpSpPr>
          <a:xfrm>
            <a:off x="278625" y="1745480"/>
            <a:ext cx="300082" cy="215444"/>
            <a:chOff x="371399" y="497340"/>
            <a:chExt cx="300082" cy="215444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AD193F0-5E21-4028-9F59-FF2B035A495F}"/>
                </a:ext>
              </a:extLst>
            </p:cNvPr>
            <p:cNvSpPr txBox="1"/>
            <p:nvPr/>
          </p:nvSpPr>
          <p:spPr>
            <a:xfrm>
              <a:off x="371399" y="4973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75D469A6-7C12-4DEB-BF66-95B9712E5C1F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6" y="608154"/>
              <a:ext cx="66425" cy="0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1817AE50-5894-489A-8162-CEB36A0A5F34}"/>
              </a:ext>
            </a:extLst>
          </p:cNvPr>
          <p:cNvGrpSpPr/>
          <p:nvPr/>
        </p:nvGrpSpPr>
        <p:grpSpPr>
          <a:xfrm>
            <a:off x="278625" y="1586457"/>
            <a:ext cx="300082" cy="215444"/>
            <a:chOff x="371399" y="497340"/>
            <a:chExt cx="300082" cy="215444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F57557E-BCC5-4512-896F-C9F64344499C}"/>
                </a:ext>
              </a:extLst>
            </p:cNvPr>
            <p:cNvSpPr txBox="1"/>
            <p:nvPr/>
          </p:nvSpPr>
          <p:spPr>
            <a:xfrm>
              <a:off x="371399" y="4973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01377EBE-9ABB-481B-BAD0-5941DBA8993D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6" y="608154"/>
              <a:ext cx="66425" cy="0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8EEB2B39-3087-49E7-A8BF-8BF9F39566D1}"/>
              </a:ext>
            </a:extLst>
          </p:cNvPr>
          <p:cNvGrpSpPr/>
          <p:nvPr/>
        </p:nvGrpSpPr>
        <p:grpSpPr>
          <a:xfrm>
            <a:off x="278625" y="1364960"/>
            <a:ext cx="300082" cy="215444"/>
            <a:chOff x="371399" y="497340"/>
            <a:chExt cx="300082" cy="215444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C7A4789-6386-4210-8997-0CC5AF23C58E}"/>
                </a:ext>
              </a:extLst>
            </p:cNvPr>
            <p:cNvSpPr txBox="1"/>
            <p:nvPr/>
          </p:nvSpPr>
          <p:spPr>
            <a:xfrm>
              <a:off x="371399" y="49734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7C0014FC-2A54-4FBE-9DE0-AF48C51D426B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6" y="608154"/>
              <a:ext cx="66425" cy="0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FE3CD860-C29A-423D-8DB1-4F88C13330C4}"/>
              </a:ext>
            </a:extLst>
          </p:cNvPr>
          <p:cNvGrpSpPr/>
          <p:nvPr/>
        </p:nvGrpSpPr>
        <p:grpSpPr>
          <a:xfrm>
            <a:off x="220917" y="1158750"/>
            <a:ext cx="357790" cy="215444"/>
            <a:chOff x="312125" y="497340"/>
            <a:chExt cx="357790" cy="215444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B7A349B-73EC-4C79-A5BA-DA22C1EA543B}"/>
                </a:ext>
              </a:extLst>
            </p:cNvPr>
            <p:cNvSpPr txBox="1"/>
            <p:nvPr/>
          </p:nvSpPr>
          <p:spPr>
            <a:xfrm>
              <a:off x="312125" y="49734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F109F782-92B5-4545-9722-4707B1DCE180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6" y="608154"/>
              <a:ext cx="66425" cy="0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4DC7BCDA-6BF3-4EDD-9CEB-A90D417BD32F}"/>
              </a:ext>
            </a:extLst>
          </p:cNvPr>
          <p:cNvSpPr txBox="1"/>
          <p:nvPr/>
        </p:nvSpPr>
        <p:spPr>
          <a:xfrm>
            <a:off x="226877" y="1007762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id="{003A4191-A68C-4549-BC18-A9D2AFA82A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8320486"/>
              </p:ext>
            </p:extLst>
          </p:nvPr>
        </p:nvGraphicFramePr>
        <p:xfrm>
          <a:off x="2867304" y="1158413"/>
          <a:ext cx="1281852" cy="8857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2" r:id="rId7" imgW="8545680" imgH="5904720" progId="">
                  <p:embed/>
                </p:oleObj>
              </mc:Choice>
              <mc:Fallback>
                <p:oleObj r:id="rId7" imgW="8545680" imgH="5904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>
                        <a:lum bright="-2000"/>
                      </a:blip>
                      <a:stretch>
                        <a:fillRect/>
                      </a:stretch>
                    </p:blipFill>
                    <p:spPr>
                      <a:xfrm>
                        <a:off x="2867304" y="1158413"/>
                        <a:ext cx="1281852" cy="8857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矩形 21">
            <a:extLst>
              <a:ext uri="{FF2B5EF4-FFF2-40B4-BE49-F238E27FC236}">
                <a16:creationId xmlns:a16="http://schemas.microsoft.com/office/drawing/2014/main" id="{1503FFEE-FB01-418E-8B86-8CB9C9F34263}"/>
              </a:ext>
            </a:extLst>
          </p:cNvPr>
          <p:cNvSpPr/>
          <p:nvPr/>
        </p:nvSpPr>
        <p:spPr>
          <a:xfrm>
            <a:off x="2884246" y="1660313"/>
            <a:ext cx="1226483" cy="304800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51DF393-95C3-482A-95E1-8FB36886B987}"/>
              </a:ext>
            </a:extLst>
          </p:cNvPr>
          <p:cNvSpPr txBox="1"/>
          <p:nvPr/>
        </p:nvSpPr>
        <p:spPr>
          <a:xfrm>
            <a:off x="4106509" y="1712685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2075A03D-55CB-4A8F-A1EB-57A408376AA8}"/>
              </a:ext>
            </a:extLst>
          </p:cNvPr>
          <p:cNvGrpSpPr/>
          <p:nvPr/>
        </p:nvGrpSpPr>
        <p:grpSpPr>
          <a:xfrm>
            <a:off x="2531739" y="1001970"/>
            <a:ext cx="373368" cy="974328"/>
            <a:chOff x="185502" y="154680"/>
            <a:chExt cx="373368" cy="974328"/>
          </a:xfrm>
        </p:grpSpPr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09325C02-D36D-4694-AD35-2C117304F0EE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C6391A8-6EAC-4DDB-ACB9-CD366DAD2197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FF0206E5-47BF-4E04-A6AC-A4A79A15D6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BEFA540D-63E4-4DCE-8366-DF7618842A57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5A389BD1-6C56-4A0D-AEFB-1F51372574EC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018B3342-9711-4204-BC9A-5E9CAF4E0F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B6AFACD4-74EB-4D9D-A4D1-C3982364D388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3B7B420-9E3C-40C5-9D6A-BBFDD3813E7A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8CFDD23F-2AC3-4A83-BF89-1778C792BF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30006D9C-8BC9-4BE7-BB93-0BED54DE4920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4E37FC75-2E88-43D6-8C82-AD1438FC6E3D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C7E09175-C823-40B8-8332-92976459C9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799D45E-2459-4282-B179-4031B1FBB283}"/>
                </a:ext>
              </a:extLst>
            </p:cNvPr>
            <p:cNvSpPr txBox="1"/>
            <p:nvPr/>
          </p:nvSpPr>
          <p:spPr>
            <a:xfrm>
              <a:off x="191462" y="154680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0" name="对象 39">
            <a:extLst>
              <a:ext uri="{FF2B5EF4-FFF2-40B4-BE49-F238E27FC236}">
                <a16:creationId xmlns:a16="http://schemas.microsoft.com/office/drawing/2014/main" id="{C6399A0A-AC1E-4448-960E-4DD778FB85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699368"/>
              </p:ext>
            </p:extLst>
          </p:nvPr>
        </p:nvGraphicFramePr>
        <p:xfrm>
          <a:off x="1944395" y="3132193"/>
          <a:ext cx="535194" cy="8933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3" r:id="rId9" imgW="3567960" imgH="5955480" progId="">
                  <p:embed/>
                </p:oleObj>
              </mc:Choice>
              <mc:Fallback>
                <p:oleObj r:id="rId9" imgW="3567960" imgH="5955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1944395" y="3132193"/>
                        <a:ext cx="535194" cy="8933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对象 40">
            <a:extLst>
              <a:ext uri="{FF2B5EF4-FFF2-40B4-BE49-F238E27FC236}">
                <a16:creationId xmlns:a16="http://schemas.microsoft.com/office/drawing/2014/main" id="{44331F25-014F-4F88-BD9B-438E9B28FF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7998022"/>
              </p:ext>
            </p:extLst>
          </p:nvPr>
        </p:nvGraphicFramePr>
        <p:xfrm>
          <a:off x="4986291" y="3089058"/>
          <a:ext cx="539028" cy="9332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4" r:id="rId11" imgW="3593520" imgH="6221880" progId="">
                  <p:embed/>
                </p:oleObj>
              </mc:Choice>
              <mc:Fallback>
                <p:oleObj r:id="rId11" imgW="3593520" imgH="62218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4986291" y="3089058"/>
                        <a:ext cx="539028" cy="9332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文本框 41">
            <a:extLst>
              <a:ext uri="{FF2B5EF4-FFF2-40B4-BE49-F238E27FC236}">
                <a16:creationId xmlns:a16="http://schemas.microsoft.com/office/drawing/2014/main" id="{AEF532EB-ED07-4391-98E9-C3F4F7E1A58F}"/>
              </a:ext>
            </a:extLst>
          </p:cNvPr>
          <p:cNvSpPr txBox="1"/>
          <p:nvPr/>
        </p:nvSpPr>
        <p:spPr>
          <a:xfrm>
            <a:off x="2452390" y="3701586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50DA15E-29AF-4E19-99AB-19137AB0A47C}"/>
              </a:ext>
            </a:extLst>
          </p:cNvPr>
          <p:cNvSpPr txBox="1"/>
          <p:nvPr/>
        </p:nvSpPr>
        <p:spPr>
          <a:xfrm>
            <a:off x="5486397" y="3673691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对象 43">
            <a:extLst>
              <a:ext uri="{FF2B5EF4-FFF2-40B4-BE49-F238E27FC236}">
                <a16:creationId xmlns:a16="http://schemas.microsoft.com/office/drawing/2014/main" id="{9784162A-57C1-42F6-8FE1-2D824CDB1F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7111675"/>
              </p:ext>
            </p:extLst>
          </p:nvPr>
        </p:nvGraphicFramePr>
        <p:xfrm>
          <a:off x="542606" y="3127895"/>
          <a:ext cx="700920" cy="94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5" r:id="rId13" imgW="4672800" imgH="6273000" progId="">
                  <p:embed/>
                </p:oleObj>
              </mc:Choice>
              <mc:Fallback>
                <p:oleObj r:id="rId13" imgW="4672800" imgH="62730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542606" y="3127895"/>
                        <a:ext cx="700920" cy="940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文本框 44">
            <a:extLst>
              <a:ext uri="{FF2B5EF4-FFF2-40B4-BE49-F238E27FC236}">
                <a16:creationId xmlns:a16="http://schemas.microsoft.com/office/drawing/2014/main" id="{6542423B-0BE8-46A2-82FC-85A820255165}"/>
              </a:ext>
            </a:extLst>
          </p:cNvPr>
          <p:cNvSpPr txBox="1"/>
          <p:nvPr/>
        </p:nvSpPr>
        <p:spPr>
          <a:xfrm>
            <a:off x="1165771" y="3629941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对象 45">
            <a:extLst>
              <a:ext uri="{FF2B5EF4-FFF2-40B4-BE49-F238E27FC236}">
                <a16:creationId xmlns:a16="http://schemas.microsoft.com/office/drawing/2014/main" id="{AD6A84F1-1E27-43D0-ABC8-6CA660BB7D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7053704"/>
              </p:ext>
            </p:extLst>
          </p:nvPr>
        </p:nvGraphicFramePr>
        <p:xfrm>
          <a:off x="3659490" y="3110535"/>
          <a:ext cx="620946" cy="8971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6" r:id="rId15" imgW="4139640" imgH="5980680" progId="">
                  <p:embed/>
                </p:oleObj>
              </mc:Choice>
              <mc:Fallback>
                <p:oleObj r:id="rId15" imgW="4139640" imgH="5980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3659490" y="3110535"/>
                        <a:ext cx="620946" cy="8971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7" name="组合 46">
            <a:extLst>
              <a:ext uri="{FF2B5EF4-FFF2-40B4-BE49-F238E27FC236}">
                <a16:creationId xmlns:a16="http://schemas.microsoft.com/office/drawing/2014/main" id="{70E03AB3-9CF0-4ED8-8E58-92AA8F853EBF}"/>
              </a:ext>
            </a:extLst>
          </p:cNvPr>
          <p:cNvGrpSpPr/>
          <p:nvPr/>
        </p:nvGrpSpPr>
        <p:grpSpPr>
          <a:xfrm>
            <a:off x="203487" y="2953775"/>
            <a:ext cx="377601" cy="974327"/>
            <a:chOff x="185502" y="154681"/>
            <a:chExt cx="377601" cy="974327"/>
          </a:xfrm>
        </p:grpSpPr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E81E7E72-96A3-4D69-AEF7-DF2C6A7193D3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24DD877F-077F-4D85-A137-757A727875AC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直接连接符 59">
                <a:extLst>
                  <a:ext uri="{FF2B5EF4-FFF2-40B4-BE49-F238E27FC236}">
                    <a16:creationId xmlns:a16="http://schemas.microsoft.com/office/drawing/2014/main" id="{0D80F0F7-B619-47BB-B9DC-A1C115AE69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C78F4409-10DC-4680-948E-9B66F6C5856F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303431C3-CDC8-45EB-9F3F-8CECF90B5B11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5F9F8051-E5FC-446C-9315-BC144CF719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4980C309-CB41-4DED-8D5F-F088D9037F78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B378115C-2D33-4EC8-AEBC-78E6A37086A8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7DB8D0D7-251C-46B0-9F3F-55BFB86281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96BD4466-1520-4349-A6F0-D15DB6ECD2EB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B5A2D172-D98F-43AE-943D-44AC3AF40B65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34A11C1C-166E-43AC-82D4-0735174475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ADABF4C3-67E1-45A6-BF4F-3ADFB736975D}"/>
                </a:ext>
              </a:extLst>
            </p:cNvPr>
            <p:cNvSpPr txBox="1"/>
            <p:nvPr/>
          </p:nvSpPr>
          <p:spPr>
            <a:xfrm>
              <a:off x="195695" y="154681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1475B3B6-AAAA-4BC5-BF56-9787D396C3C1}"/>
              </a:ext>
            </a:extLst>
          </p:cNvPr>
          <p:cNvGrpSpPr/>
          <p:nvPr/>
        </p:nvGrpSpPr>
        <p:grpSpPr>
          <a:xfrm>
            <a:off x="3321113" y="2991310"/>
            <a:ext cx="373368" cy="970096"/>
            <a:chOff x="185502" y="158912"/>
            <a:chExt cx="373368" cy="970096"/>
          </a:xfrm>
        </p:grpSpPr>
        <p:grpSp>
          <p:nvGrpSpPr>
            <p:cNvPr id="62" name="组合 61">
              <a:extLst>
                <a:ext uri="{FF2B5EF4-FFF2-40B4-BE49-F238E27FC236}">
                  <a16:creationId xmlns:a16="http://schemas.microsoft.com/office/drawing/2014/main" id="{A5582A68-37BA-4AE0-AA08-3AB0AC47C673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B5160380-7FF0-42BB-A207-648DB0DF1953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4" name="直接连接符 73">
                <a:extLst>
                  <a:ext uri="{FF2B5EF4-FFF2-40B4-BE49-F238E27FC236}">
                    <a16:creationId xmlns:a16="http://schemas.microsoft.com/office/drawing/2014/main" id="{4B856A89-F36A-465F-84A3-6108917F36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E36125AE-E871-4A8D-A481-CC78E5AE7F14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B574E0EA-0448-45A1-B3CB-E729B99D48E4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C46DD17D-38DD-4933-A74A-287677ADC1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08C98546-17AE-4F23-9E4E-33301EE5E9B0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5EE41E29-D3EB-42F5-95B2-2F7F4B76076F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0" name="直接连接符 69">
                <a:extLst>
                  <a:ext uri="{FF2B5EF4-FFF2-40B4-BE49-F238E27FC236}">
                    <a16:creationId xmlns:a16="http://schemas.microsoft.com/office/drawing/2014/main" id="{D00E7E12-C952-4EE5-949B-378DFD493E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B71154CE-CC0D-4749-B7EB-A46FC855C0F7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DD8BE41A-1FB3-43E2-A93D-CC7A8B25B2A6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F2CA2295-E28C-489A-8913-9FBA2044B8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6DBE70DF-FA5A-4F34-9E72-4FCD9D94675C}"/>
                </a:ext>
              </a:extLst>
            </p:cNvPr>
            <p:cNvSpPr txBox="1"/>
            <p:nvPr/>
          </p:nvSpPr>
          <p:spPr>
            <a:xfrm>
              <a:off x="191462" y="158912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5" name="矩形 74">
            <a:extLst>
              <a:ext uri="{FF2B5EF4-FFF2-40B4-BE49-F238E27FC236}">
                <a16:creationId xmlns:a16="http://schemas.microsoft.com/office/drawing/2014/main" id="{97563B07-5127-4448-B597-5761030943A7}"/>
              </a:ext>
            </a:extLst>
          </p:cNvPr>
          <p:cNvSpPr/>
          <p:nvPr/>
        </p:nvSpPr>
        <p:spPr>
          <a:xfrm>
            <a:off x="661221" y="3603410"/>
            <a:ext cx="476948" cy="233397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02DC6B58-0304-4AAC-9C64-58C965B0496E}"/>
              </a:ext>
            </a:extLst>
          </p:cNvPr>
          <p:cNvSpPr/>
          <p:nvPr/>
        </p:nvSpPr>
        <p:spPr>
          <a:xfrm>
            <a:off x="3738434" y="3645813"/>
            <a:ext cx="457228" cy="227933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C3CE68CC-4CD2-4E90-9E68-F433352ED3A9}"/>
              </a:ext>
            </a:extLst>
          </p:cNvPr>
          <p:cNvSpPr/>
          <p:nvPr/>
        </p:nvSpPr>
        <p:spPr>
          <a:xfrm>
            <a:off x="1953123" y="3685396"/>
            <a:ext cx="489373" cy="233397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791AEAD4-1B6F-414F-9909-AB116E9AFC32}"/>
              </a:ext>
            </a:extLst>
          </p:cNvPr>
          <p:cNvSpPr/>
          <p:nvPr/>
        </p:nvSpPr>
        <p:spPr>
          <a:xfrm>
            <a:off x="5010431" y="3651273"/>
            <a:ext cx="489373" cy="233397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DB89E43D-F909-450B-BCFE-E137D15F9E84}"/>
              </a:ext>
            </a:extLst>
          </p:cNvPr>
          <p:cNvGrpSpPr/>
          <p:nvPr/>
        </p:nvGrpSpPr>
        <p:grpSpPr>
          <a:xfrm>
            <a:off x="1588285" y="3005949"/>
            <a:ext cx="373368" cy="978562"/>
            <a:chOff x="185502" y="150446"/>
            <a:chExt cx="373368" cy="978562"/>
          </a:xfrm>
        </p:grpSpPr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BD837A7B-08F8-4081-8577-C4F7252B4C65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B7CD1C88-A321-48C6-84A0-B5FEEF0E2C1A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98C42B90-957A-432E-96DE-2F0D8CC5DF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6630806C-8383-427D-B668-B4F82AD85A54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7B1591D6-E144-4160-A1CF-8E9BB64FB26C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8F1AD14F-E27D-46B8-88EE-822F3ACE28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EAB395DB-9E27-48BF-9E39-6F3BB1194630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450F3E4D-B036-4C83-A0C8-5049E920171A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9" name="直接连接符 88">
                <a:extLst>
                  <a:ext uri="{FF2B5EF4-FFF2-40B4-BE49-F238E27FC236}">
                    <a16:creationId xmlns:a16="http://schemas.microsoft.com/office/drawing/2014/main" id="{2309389A-B395-4FC6-AC53-1E6E89E7A6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EA92A997-1456-4A41-8677-D0A93C451E2A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CF4B2A51-BDC2-493D-BCF0-DB60910D5060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直接连接符 86">
                <a:extLst>
                  <a:ext uri="{FF2B5EF4-FFF2-40B4-BE49-F238E27FC236}">
                    <a16:creationId xmlns:a16="http://schemas.microsoft.com/office/drawing/2014/main" id="{66EBF801-AF11-496F-AE93-C452E0C237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9A650F62-653B-4105-919B-8D00CC02C7F6}"/>
                </a:ext>
              </a:extLst>
            </p:cNvPr>
            <p:cNvSpPr txBox="1"/>
            <p:nvPr/>
          </p:nvSpPr>
          <p:spPr>
            <a:xfrm>
              <a:off x="191462" y="150446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组合 93">
            <a:extLst>
              <a:ext uri="{FF2B5EF4-FFF2-40B4-BE49-F238E27FC236}">
                <a16:creationId xmlns:a16="http://schemas.microsoft.com/office/drawing/2014/main" id="{6608A6FB-64F6-451E-8CC7-0C2CB947B831}"/>
              </a:ext>
            </a:extLst>
          </p:cNvPr>
          <p:cNvGrpSpPr/>
          <p:nvPr/>
        </p:nvGrpSpPr>
        <p:grpSpPr>
          <a:xfrm>
            <a:off x="4650258" y="2983691"/>
            <a:ext cx="373368" cy="974328"/>
            <a:chOff x="185502" y="154680"/>
            <a:chExt cx="373368" cy="974328"/>
          </a:xfrm>
        </p:grpSpPr>
        <p:grpSp>
          <p:nvGrpSpPr>
            <p:cNvPr id="95" name="组合 94">
              <a:extLst>
                <a:ext uri="{FF2B5EF4-FFF2-40B4-BE49-F238E27FC236}">
                  <a16:creationId xmlns:a16="http://schemas.microsoft.com/office/drawing/2014/main" id="{B5700704-C6C0-43DC-955D-84BE7ACD7CAF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9C7A1D69-FAFC-4A90-9184-A206DEAFD15C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B1135BB9-2880-43E3-B66A-7CD27B93D7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组合 95">
              <a:extLst>
                <a:ext uri="{FF2B5EF4-FFF2-40B4-BE49-F238E27FC236}">
                  <a16:creationId xmlns:a16="http://schemas.microsoft.com/office/drawing/2014/main" id="{994C66BB-589C-40BF-979C-59F0E099688B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06115F95-F0AB-4AFE-A723-3B4CD61F17E0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5" name="直接连接符 104">
                <a:extLst>
                  <a:ext uri="{FF2B5EF4-FFF2-40B4-BE49-F238E27FC236}">
                    <a16:creationId xmlns:a16="http://schemas.microsoft.com/office/drawing/2014/main" id="{34AD4A67-3314-4081-8A69-F40E1310E5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组合 96">
              <a:extLst>
                <a:ext uri="{FF2B5EF4-FFF2-40B4-BE49-F238E27FC236}">
                  <a16:creationId xmlns:a16="http://schemas.microsoft.com/office/drawing/2014/main" id="{19F835D5-1A63-4F06-8C31-8F941175DD3E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8FA697A1-ED70-444C-8D88-D569B11E6B00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3" name="直接连接符 102">
                <a:extLst>
                  <a:ext uri="{FF2B5EF4-FFF2-40B4-BE49-F238E27FC236}">
                    <a16:creationId xmlns:a16="http://schemas.microsoft.com/office/drawing/2014/main" id="{C19F80E5-E35B-40BD-98B1-848C42BE6F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FCB87E4B-E06E-4730-93E0-ECA0F85DEEA6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208A0E6F-9D3C-48F5-8A33-B6CFFFDCFFCC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1" name="直接连接符 100">
                <a:extLst>
                  <a:ext uri="{FF2B5EF4-FFF2-40B4-BE49-F238E27FC236}">
                    <a16:creationId xmlns:a16="http://schemas.microsoft.com/office/drawing/2014/main" id="{DBF62A53-BE30-4528-80A0-2B12EB63C7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5981E4C4-C377-42A6-B797-FCBB369226C1}"/>
                </a:ext>
              </a:extLst>
            </p:cNvPr>
            <p:cNvSpPr txBox="1"/>
            <p:nvPr/>
          </p:nvSpPr>
          <p:spPr>
            <a:xfrm>
              <a:off x="191462" y="154680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8" name="文本框 107">
            <a:extLst>
              <a:ext uri="{FF2B5EF4-FFF2-40B4-BE49-F238E27FC236}">
                <a16:creationId xmlns:a16="http://schemas.microsoft.com/office/drawing/2014/main" id="{DC72D669-099C-4DB4-AFF0-FC2039CF1B23}"/>
              </a:ext>
            </a:extLst>
          </p:cNvPr>
          <p:cNvSpPr txBox="1"/>
          <p:nvPr/>
        </p:nvSpPr>
        <p:spPr>
          <a:xfrm>
            <a:off x="4224771" y="3648849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5666712B-D9D9-4D7C-B82C-21B235E6E78B}"/>
              </a:ext>
            </a:extLst>
          </p:cNvPr>
          <p:cNvSpPr txBox="1"/>
          <p:nvPr/>
        </p:nvSpPr>
        <p:spPr>
          <a:xfrm>
            <a:off x="1199498" y="4166297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8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80940258-4940-4EB7-8587-0D62A47B5E9E}"/>
              </a:ext>
            </a:extLst>
          </p:cNvPr>
          <p:cNvSpPr txBox="1"/>
          <p:nvPr/>
        </p:nvSpPr>
        <p:spPr>
          <a:xfrm>
            <a:off x="4263456" y="4166297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8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7217670-948B-46A8-B19B-AB7A05C6C986}"/>
              </a:ext>
            </a:extLst>
          </p:cNvPr>
          <p:cNvSpPr txBox="1"/>
          <p:nvPr/>
        </p:nvSpPr>
        <p:spPr>
          <a:xfrm>
            <a:off x="1201902" y="6113469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8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24631791-DC79-46E7-97EB-456247386003}"/>
              </a:ext>
            </a:extLst>
          </p:cNvPr>
          <p:cNvSpPr txBox="1"/>
          <p:nvPr/>
        </p:nvSpPr>
        <p:spPr>
          <a:xfrm>
            <a:off x="4269066" y="6113469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8F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B68B4AEE-8210-4287-A75B-EF0F1205872B}"/>
              </a:ext>
            </a:extLst>
          </p:cNvPr>
          <p:cNvSpPr txBox="1"/>
          <p:nvPr/>
        </p:nvSpPr>
        <p:spPr>
          <a:xfrm>
            <a:off x="1196292" y="8058248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8G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组合 115">
            <a:extLst>
              <a:ext uri="{FF2B5EF4-FFF2-40B4-BE49-F238E27FC236}">
                <a16:creationId xmlns:a16="http://schemas.microsoft.com/office/drawing/2014/main" id="{2E699854-398B-4002-8957-4B3BAA35ED0A}"/>
              </a:ext>
            </a:extLst>
          </p:cNvPr>
          <p:cNvGrpSpPr/>
          <p:nvPr/>
        </p:nvGrpSpPr>
        <p:grpSpPr>
          <a:xfrm>
            <a:off x="268861" y="5003304"/>
            <a:ext cx="373368" cy="974329"/>
            <a:chOff x="185502" y="154679"/>
            <a:chExt cx="373368" cy="974329"/>
          </a:xfrm>
        </p:grpSpPr>
        <p:grpSp>
          <p:nvGrpSpPr>
            <p:cNvPr id="117" name="组合 116">
              <a:extLst>
                <a:ext uri="{FF2B5EF4-FFF2-40B4-BE49-F238E27FC236}">
                  <a16:creationId xmlns:a16="http://schemas.microsoft.com/office/drawing/2014/main" id="{C3593BE7-71A5-4519-9019-53AEC5F53541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BAAF29DB-DCF3-4FE6-BA5F-F528E0879CCD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9" name="直接连接符 128">
                <a:extLst>
                  <a:ext uri="{FF2B5EF4-FFF2-40B4-BE49-F238E27FC236}">
                    <a16:creationId xmlns:a16="http://schemas.microsoft.com/office/drawing/2014/main" id="{1E69C1BF-13E0-48C3-9410-B3A6F64A8C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8" name="组合 117">
              <a:extLst>
                <a:ext uri="{FF2B5EF4-FFF2-40B4-BE49-F238E27FC236}">
                  <a16:creationId xmlns:a16="http://schemas.microsoft.com/office/drawing/2014/main" id="{6483B58B-65DD-4A8C-95E0-03AF8AEC8787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779AD55F-8439-44CF-B29D-3FD089A31229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7" name="直接连接符 126">
                <a:extLst>
                  <a:ext uri="{FF2B5EF4-FFF2-40B4-BE49-F238E27FC236}">
                    <a16:creationId xmlns:a16="http://schemas.microsoft.com/office/drawing/2014/main" id="{69398AAD-7747-4D47-AE8A-A8B528BD37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组合 118">
              <a:extLst>
                <a:ext uri="{FF2B5EF4-FFF2-40B4-BE49-F238E27FC236}">
                  <a16:creationId xmlns:a16="http://schemas.microsoft.com/office/drawing/2014/main" id="{AB1EB73D-8314-46D0-85B2-3FB637CC0612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E2F33A0A-B5DA-425A-B158-0E2CF40876E1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55650D38-ECAC-401B-8477-D753048938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0" name="组合 119">
              <a:extLst>
                <a:ext uri="{FF2B5EF4-FFF2-40B4-BE49-F238E27FC236}">
                  <a16:creationId xmlns:a16="http://schemas.microsoft.com/office/drawing/2014/main" id="{8031F14B-5BA3-4580-815A-852ECD127243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BC0C9662-A943-479F-AC2A-C2254A454EA9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3" name="直接连接符 122">
                <a:extLst>
                  <a:ext uri="{FF2B5EF4-FFF2-40B4-BE49-F238E27FC236}">
                    <a16:creationId xmlns:a16="http://schemas.microsoft.com/office/drawing/2014/main" id="{4F557067-F065-4204-AB9D-A114095DAC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692A02E5-39E6-447B-9FFB-785A897C923E}"/>
                </a:ext>
              </a:extLst>
            </p:cNvPr>
            <p:cNvSpPr txBox="1"/>
            <p:nvPr/>
          </p:nvSpPr>
          <p:spPr>
            <a:xfrm>
              <a:off x="191462" y="15467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0" name="矩形 129">
            <a:extLst>
              <a:ext uri="{FF2B5EF4-FFF2-40B4-BE49-F238E27FC236}">
                <a16:creationId xmlns:a16="http://schemas.microsoft.com/office/drawing/2014/main" id="{FFE82577-8357-4B46-82A1-F6523CB49C61}"/>
              </a:ext>
            </a:extLst>
          </p:cNvPr>
          <p:cNvSpPr/>
          <p:nvPr/>
        </p:nvSpPr>
        <p:spPr>
          <a:xfrm>
            <a:off x="753118" y="5706358"/>
            <a:ext cx="354233" cy="177992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B3380031-8D29-4429-8CBE-FC8CF2C4BEA7}"/>
              </a:ext>
            </a:extLst>
          </p:cNvPr>
          <p:cNvSpPr txBox="1"/>
          <p:nvPr/>
        </p:nvSpPr>
        <p:spPr>
          <a:xfrm>
            <a:off x="1165771" y="5687471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3" name="对象 132">
            <a:extLst>
              <a:ext uri="{FF2B5EF4-FFF2-40B4-BE49-F238E27FC236}">
                <a16:creationId xmlns:a16="http://schemas.microsoft.com/office/drawing/2014/main" id="{C9000568-9FDD-462E-AD77-F3082C490B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6877477"/>
              </p:ext>
            </p:extLst>
          </p:nvPr>
        </p:nvGraphicFramePr>
        <p:xfrm>
          <a:off x="3650541" y="4978873"/>
          <a:ext cx="622152" cy="1018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7" r:id="rId17" imgW="3110760" imgH="5091840" progId="">
                  <p:embed/>
                </p:oleObj>
              </mc:Choice>
              <mc:Fallback>
                <p:oleObj r:id="rId17" imgW="3110760" imgH="5091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650541" y="4978873"/>
                        <a:ext cx="622152" cy="1018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34" name="组合 133">
            <a:extLst>
              <a:ext uri="{FF2B5EF4-FFF2-40B4-BE49-F238E27FC236}">
                <a16:creationId xmlns:a16="http://schemas.microsoft.com/office/drawing/2014/main" id="{9EDFAC3F-C7A7-4247-9AF9-DF5A13E81F27}"/>
              </a:ext>
            </a:extLst>
          </p:cNvPr>
          <p:cNvGrpSpPr/>
          <p:nvPr/>
        </p:nvGrpSpPr>
        <p:grpSpPr>
          <a:xfrm>
            <a:off x="3304520" y="5029024"/>
            <a:ext cx="373368" cy="948929"/>
            <a:chOff x="185502" y="180079"/>
            <a:chExt cx="373368" cy="948929"/>
          </a:xfrm>
        </p:grpSpPr>
        <p:grpSp>
          <p:nvGrpSpPr>
            <p:cNvPr id="135" name="组合 134">
              <a:extLst>
                <a:ext uri="{FF2B5EF4-FFF2-40B4-BE49-F238E27FC236}">
                  <a16:creationId xmlns:a16="http://schemas.microsoft.com/office/drawing/2014/main" id="{C2FDC111-4BE8-4583-A710-1A60A437747E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9A8E34A3-0A68-4E65-9A7D-EAB682DB1815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7" name="直接连接符 146">
                <a:extLst>
                  <a:ext uri="{FF2B5EF4-FFF2-40B4-BE49-F238E27FC236}">
                    <a16:creationId xmlns:a16="http://schemas.microsoft.com/office/drawing/2014/main" id="{B59ED937-6FF0-484A-B526-F89DE310EB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6" name="组合 135">
              <a:extLst>
                <a:ext uri="{FF2B5EF4-FFF2-40B4-BE49-F238E27FC236}">
                  <a16:creationId xmlns:a16="http://schemas.microsoft.com/office/drawing/2014/main" id="{2CAE502F-4608-4CD7-A383-BB1540475829}"/>
                </a:ext>
              </a:extLst>
            </p:cNvPr>
            <p:cNvGrpSpPr/>
            <p:nvPr/>
          </p:nvGrpSpPr>
          <p:grpSpPr>
            <a:xfrm>
              <a:off x="243210" y="770416"/>
              <a:ext cx="300082" cy="215444"/>
              <a:chOff x="371399" y="513215"/>
              <a:chExt cx="300082" cy="215444"/>
            </a:xfrm>
          </p:grpSpPr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20196FB2-707C-4365-97AE-D7B25803A66F}"/>
                  </a:ext>
                </a:extLst>
              </p:cNvPr>
              <p:cNvSpPr txBox="1"/>
              <p:nvPr/>
            </p:nvSpPr>
            <p:spPr>
              <a:xfrm>
                <a:off x="371399" y="51321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5" name="直接连接符 144">
                <a:extLst>
                  <a:ext uri="{FF2B5EF4-FFF2-40B4-BE49-F238E27FC236}">
                    <a16:creationId xmlns:a16="http://schemas.microsoft.com/office/drawing/2014/main" id="{1EC96D8E-D981-4B1A-944B-D67648C2C2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24029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组合 136">
              <a:extLst>
                <a:ext uri="{FF2B5EF4-FFF2-40B4-BE49-F238E27FC236}">
                  <a16:creationId xmlns:a16="http://schemas.microsoft.com/office/drawing/2014/main" id="{22BC1CE2-220F-4528-BF1D-5B4979900EC9}"/>
                </a:ext>
              </a:extLst>
            </p:cNvPr>
            <p:cNvGrpSpPr/>
            <p:nvPr/>
          </p:nvGrpSpPr>
          <p:grpSpPr>
            <a:xfrm>
              <a:off x="243210" y="561621"/>
              <a:ext cx="300082" cy="215444"/>
              <a:chOff x="371399" y="525917"/>
              <a:chExt cx="300082" cy="215444"/>
            </a:xfrm>
          </p:grpSpPr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E49351CF-04A8-4799-B0AB-147D43FABF51}"/>
                  </a:ext>
                </a:extLst>
              </p:cNvPr>
              <p:cNvSpPr txBox="1"/>
              <p:nvPr/>
            </p:nvSpPr>
            <p:spPr>
              <a:xfrm>
                <a:off x="371399" y="52591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直接连接符 142">
                <a:extLst>
                  <a:ext uri="{FF2B5EF4-FFF2-40B4-BE49-F238E27FC236}">
                    <a16:creationId xmlns:a16="http://schemas.microsoft.com/office/drawing/2014/main" id="{EFF14929-42E1-4BE0-8B5F-C1FDEF7B06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6731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8" name="组合 137">
              <a:extLst>
                <a:ext uri="{FF2B5EF4-FFF2-40B4-BE49-F238E27FC236}">
                  <a16:creationId xmlns:a16="http://schemas.microsoft.com/office/drawing/2014/main" id="{85AFD66B-2D33-4B63-B349-3C31CF10C3DA}"/>
                </a:ext>
              </a:extLst>
            </p:cNvPr>
            <p:cNvGrpSpPr/>
            <p:nvPr/>
          </p:nvGrpSpPr>
          <p:grpSpPr>
            <a:xfrm>
              <a:off x="185502" y="350121"/>
              <a:ext cx="357790" cy="215444"/>
              <a:chOff x="312125" y="520627"/>
              <a:chExt cx="357790" cy="215444"/>
            </a:xfrm>
          </p:grpSpPr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A78333EF-033A-4C43-BDF5-F94E408E59E3}"/>
                  </a:ext>
                </a:extLst>
              </p:cNvPr>
              <p:cNvSpPr txBox="1"/>
              <p:nvPr/>
            </p:nvSpPr>
            <p:spPr>
              <a:xfrm>
                <a:off x="312125" y="520627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1" name="直接连接符 140">
                <a:extLst>
                  <a:ext uri="{FF2B5EF4-FFF2-40B4-BE49-F238E27FC236}">
                    <a16:creationId xmlns:a16="http://schemas.microsoft.com/office/drawing/2014/main" id="{E0513914-8E7D-4D15-AA60-87EFA8FB9B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1441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3F20C291-C960-49FD-9802-2E259B7C42BE}"/>
                </a:ext>
              </a:extLst>
            </p:cNvPr>
            <p:cNvSpPr txBox="1"/>
            <p:nvPr/>
          </p:nvSpPr>
          <p:spPr>
            <a:xfrm>
              <a:off x="191462" y="18007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8" name="矩形 147">
            <a:extLst>
              <a:ext uri="{FF2B5EF4-FFF2-40B4-BE49-F238E27FC236}">
                <a16:creationId xmlns:a16="http://schemas.microsoft.com/office/drawing/2014/main" id="{D4C90875-0D45-4DBB-BB7D-EBE7799F9D07}"/>
              </a:ext>
            </a:extLst>
          </p:cNvPr>
          <p:cNvSpPr/>
          <p:nvPr/>
        </p:nvSpPr>
        <p:spPr>
          <a:xfrm>
            <a:off x="3788777" y="5693978"/>
            <a:ext cx="354233" cy="190371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B1525AAA-4C9C-4EC2-BD47-EEE66376BA5F}"/>
              </a:ext>
            </a:extLst>
          </p:cNvPr>
          <p:cNvSpPr txBox="1"/>
          <p:nvPr/>
        </p:nvSpPr>
        <p:spPr>
          <a:xfrm>
            <a:off x="4224771" y="5678540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0" name="对象 149">
            <a:extLst>
              <a:ext uri="{FF2B5EF4-FFF2-40B4-BE49-F238E27FC236}">
                <a16:creationId xmlns:a16="http://schemas.microsoft.com/office/drawing/2014/main" id="{63F76449-725A-408C-BCCD-06DD78DC2E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441349"/>
              </p:ext>
            </p:extLst>
          </p:nvPr>
        </p:nvGraphicFramePr>
        <p:xfrm>
          <a:off x="471488" y="6853238"/>
          <a:ext cx="801687" cy="1096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8" r:id="rId19" imgW="4012560" imgH="5485680" progId="">
                  <p:embed/>
                </p:oleObj>
              </mc:Choice>
              <mc:Fallback>
                <p:oleObj r:id="rId19" imgW="4012560" imgH="5485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1488" y="6853238"/>
                        <a:ext cx="801687" cy="1096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1" name="组合 150">
            <a:extLst>
              <a:ext uri="{FF2B5EF4-FFF2-40B4-BE49-F238E27FC236}">
                <a16:creationId xmlns:a16="http://schemas.microsoft.com/office/drawing/2014/main" id="{D1F5D137-6109-415B-BB2C-BDB38FC2974A}"/>
              </a:ext>
            </a:extLst>
          </p:cNvPr>
          <p:cNvGrpSpPr/>
          <p:nvPr/>
        </p:nvGrpSpPr>
        <p:grpSpPr>
          <a:xfrm>
            <a:off x="135665" y="6940497"/>
            <a:ext cx="373368" cy="1008194"/>
            <a:chOff x="185502" y="120814"/>
            <a:chExt cx="373368" cy="1008194"/>
          </a:xfrm>
        </p:grpSpPr>
        <p:grpSp>
          <p:nvGrpSpPr>
            <p:cNvPr id="152" name="组合 151">
              <a:extLst>
                <a:ext uri="{FF2B5EF4-FFF2-40B4-BE49-F238E27FC236}">
                  <a16:creationId xmlns:a16="http://schemas.microsoft.com/office/drawing/2014/main" id="{93C9531F-D9BB-44E2-BB7A-DEBD026B36D9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BD774B6D-024A-4D0F-9A16-B48E14512770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4" name="直接连接符 163">
                <a:extLst>
                  <a:ext uri="{FF2B5EF4-FFF2-40B4-BE49-F238E27FC236}">
                    <a16:creationId xmlns:a16="http://schemas.microsoft.com/office/drawing/2014/main" id="{3D272429-A0BB-45A4-81BC-17C8372583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3" name="组合 152">
              <a:extLst>
                <a:ext uri="{FF2B5EF4-FFF2-40B4-BE49-F238E27FC236}">
                  <a16:creationId xmlns:a16="http://schemas.microsoft.com/office/drawing/2014/main" id="{B575ED03-85DC-405F-B66E-3BCE958D55A0}"/>
                </a:ext>
              </a:extLst>
            </p:cNvPr>
            <p:cNvGrpSpPr/>
            <p:nvPr/>
          </p:nvGrpSpPr>
          <p:grpSpPr>
            <a:xfrm>
              <a:off x="243210" y="786291"/>
              <a:ext cx="300082" cy="215444"/>
              <a:chOff x="371399" y="529090"/>
              <a:chExt cx="300082" cy="215444"/>
            </a:xfrm>
          </p:grpSpPr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7B8158DC-4349-472F-B512-0E4868C836CD}"/>
                  </a:ext>
                </a:extLst>
              </p:cNvPr>
              <p:cNvSpPr txBox="1"/>
              <p:nvPr/>
            </p:nvSpPr>
            <p:spPr>
              <a:xfrm>
                <a:off x="371399" y="529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2" name="直接连接符 161">
                <a:extLst>
                  <a:ext uri="{FF2B5EF4-FFF2-40B4-BE49-F238E27FC236}">
                    <a16:creationId xmlns:a16="http://schemas.microsoft.com/office/drawing/2014/main" id="{77CA4154-36DC-4995-9CF6-D2126FAD2B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990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组合 153">
              <a:extLst>
                <a:ext uri="{FF2B5EF4-FFF2-40B4-BE49-F238E27FC236}">
                  <a16:creationId xmlns:a16="http://schemas.microsoft.com/office/drawing/2014/main" id="{30793FF1-37CB-4FF7-A4DF-7616FE92F05D}"/>
                </a:ext>
              </a:extLst>
            </p:cNvPr>
            <p:cNvGrpSpPr/>
            <p:nvPr/>
          </p:nvGrpSpPr>
          <p:grpSpPr>
            <a:xfrm>
              <a:off x="243210" y="609244"/>
              <a:ext cx="300082" cy="215444"/>
              <a:chOff x="371399" y="573540"/>
              <a:chExt cx="300082" cy="215444"/>
            </a:xfrm>
          </p:grpSpPr>
          <p:sp>
            <p:nvSpPr>
              <p:cNvPr id="159" name="文本框 158">
                <a:extLst>
                  <a:ext uri="{FF2B5EF4-FFF2-40B4-BE49-F238E27FC236}">
                    <a16:creationId xmlns:a16="http://schemas.microsoft.com/office/drawing/2014/main" id="{1BA6A958-BB45-4594-AF02-1FC9285C726D}"/>
                  </a:ext>
                </a:extLst>
              </p:cNvPr>
              <p:cNvSpPr txBox="1"/>
              <p:nvPr/>
            </p:nvSpPr>
            <p:spPr>
              <a:xfrm>
                <a:off x="371399" y="5735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0" name="直接连接符 159">
                <a:extLst>
                  <a:ext uri="{FF2B5EF4-FFF2-40B4-BE49-F238E27FC236}">
                    <a16:creationId xmlns:a16="http://schemas.microsoft.com/office/drawing/2014/main" id="{10C873C5-8819-47C6-89D7-0CCD527FD6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843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0CECA6AE-4F43-48ED-A98C-4A9AFF7EF9D2}"/>
                </a:ext>
              </a:extLst>
            </p:cNvPr>
            <p:cNvGrpSpPr/>
            <p:nvPr/>
          </p:nvGrpSpPr>
          <p:grpSpPr>
            <a:xfrm>
              <a:off x="185502" y="288734"/>
              <a:ext cx="357790" cy="215444"/>
              <a:chOff x="312125" y="459240"/>
              <a:chExt cx="357790" cy="215444"/>
            </a:xfrm>
          </p:grpSpPr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20E29E66-3CD2-4954-A197-864A2A27DBFF}"/>
                  </a:ext>
                </a:extLst>
              </p:cNvPr>
              <p:cNvSpPr txBox="1"/>
              <p:nvPr/>
            </p:nvSpPr>
            <p:spPr>
              <a:xfrm>
                <a:off x="312125" y="4592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8" name="直接连接符 157">
                <a:extLst>
                  <a:ext uri="{FF2B5EF4-FFF2-40B4-BE49-F238E27FC236}">
                    <a16:creationId xmlns:a16="http://schemas.microsoft.com/office/drawing/2014/main" id="{96E2416D-719C-4D0A-ADA2-5E070D815A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5700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0CC1673D-E233-4F97-9CFC-E7A1215A1698}"/>
                </a:ext>
              </a:extLst>
            </p:cNvPr>
            <p:cNvSpPr txBox="1"/>
            <p:nvPr/>
          </p:nvSpPr>
          <p:spPr>
            <a:xfrm>
              <a:off x="191462" y="120814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5" name="矩形 164">
            <a:extLst>
              <a:ext uri="{FF2B5EF4-FFF2-40B4-BE49-F238E27FC236}">
                <a16:creationId xmlns:a16="http://schemas.microsoft.com/office/drawing/2014/main" id="{6EF9AD10-C2B2-4CA5-B35D-4C89D3CD4D46}"/>
              </a:ext>
            </a:extLst>
          </p:cNvPr>
          <p:cNvSpPr/>
          <p:nvPr/>
        </p:nvSpPr>
        <p:spPr>
          <a:xfrm>
            <a:off x="756448" y="7670008"/>
            <a:ext cx="354233" cy="188849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6BDE4CA3-7527-4D38-803B-99C3A5D1240F}"/>
              </a:ext>
            </a:extLst>
          </p:cNvPr>
          <p:cNvSpPr txBox="1"/>
          <p:nvPr/>
        </p:nvSpPr>
        <p:spPr>
          <a:xfrm>
            <a:off x="1165771" y="7658803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SSC4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7" name="对象 166">
            <a:extLst>
              <a:ext uri="{FF2B5EF4-FFF2-40B4-BE49-F238E27FC236}">
                <a16:creationId xmlns:a16="http://schemas.microsoft.com/office/drawing/2014/main" id="{C93CC6E9-A256-4F43-885D-B91B871708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8274970"/>
              </p:ext>
            </p:extLst>
          </p:nvPr>
        </p:nvGraphicFramePr>
        <p:xfrm>
          <a:off x="1931739" y="6965261"/>
          <a:ext cx="591696" cy="965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09" r:id="rId21" imgW="2958480" imgH="4825080" progId="">
                  <p:embed/>
                </p:oleObj>
              </mc:Choice>
              <mc:Fallback>
                <p:oleObj r:id="rId21" imgW="2958480" imgH="4825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1931739" y="6965261"/>
                        <a:ext cx="591696" cy="965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8" name="组合 167">
            <a:extLst>
              <a:ext uri="{FF2B5EF4-FFF2-40B4-BE49-F238E27FC236}">
                <a16:creationId xmlns:a16="http://schemas.microsoft.com/office/drawing/2014/main" id="{323A6AD5-C6DB-4FE9-AD6A-0CF368153509}"/>
              </a:ext>
            </a:extLst>
          </p:cNvPr>
          <p:cNvGrpSpPr/>
          <p:nvPr/>
        </p:nvGrpSpPr>
        <p:grpSpPr>
          <a:xfrm>
            <a:off x="1602803" y="6920388"/>
            <a:ext cx="373368" cy="1003962"/>
            <a:chOff x="185502" y="125046"/>
            <a:chExt cx="373368" cy="1003962"/>
          </a:xfrm>
        </p:grpSpPr>
        <p:grpSp>
          <p:nvGrpSpPr>
            <p:cNvPr id="169" name="组合 168">
              <a:extLst>
                <a:ext uri="{FF2B5EF4-FFF2-40B4-BE49-F238E27FC236}">
                  <a16:creationId xmlns:a16="http://schemas.microsoft.com/office/drawing/2014/main" id="{8B508BE1-335F-40F2-94A6-0390F75DEFEB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AE70B7D2-996F-4CC0-AF59-C468C069DBFA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1" name="直接连接符 180">
                <a:extLst>
                  <a:ext uri="{FF2B5EF4-FFF2-40B4-BE49-F238E27FC236}">
                    <a16:creationId xmlns:a16="http://schemas.microsoft.com/office/drawing/2014/main" id="{6C21C974-3821-444C-814A-9C936D23B7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0" name="组合 169">
              <a:extLst>
                <a:ext uri="{FF2B5EF4-FFF2-40B4-BE49-F238E27FC236}">
                  <a16:creationId xmlns:a16="http://schemas.microsoft.com/office/drawing/2014/main" id="{A0BAEEC3-CEF7-46D3-BD53-856FC2B03CEA}"/>
                </a:ext>
              </a:extLst>
            </p:cNvPr>
            <p:cNvGrpSpPr/>
            <p:nvPr/>
          </p:nvGrpSpPr>
          <p:grpSpPr>
            <a:xfrm>
              <a:off x="243210" y="786291"/>
              <a:ext cx="300082" cy="215444"/>
              <a:chOff x="371399" y="529090"/>
              <a:chExt cx="300082" cy="215444"/>
            </a:xfrm>
          </p:grpSpPr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7AD69289-4C56-4CC1-BC70-0E6FABA6BC38}"/>
                  </a:ext>
                </a:extLst>
              </p:cNvPr>
              <p:cNvSpPr txBox="1"/>
              <p:nvPr/>
            </p:nvSpPr>
            <p:spPr>
              <a:xfrm>
                <a:off x="371399" y="529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9" name="直接连接符 178">
                <a:extLst>
                  <a:ext uri="{FF2B5EF4-FFF2-40B4-BE49-F238E27FC236}">
                    <a16:creationId xmlns:a16="http://schemas.microsoft.com/office/drawing/2014/main" id="{A2D3771B-2C73-4BC6-8534-15400E7AA0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990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组合 170">
              <a:extLst>
                <a:ext uri="{FF2B5EF4-FFF2-40B4-BE49-F238E27FC236}">
                  <a16:creationId xmlns:a16="http://schemas.microsoft.com/office/drawing/2014/main" id="{3691F737-042F-4372-B25B-878D673E1C96}"/>
                </a:ext>
              </a:extLst>
            </p:cNvPr>
            <p:cNvGrpSpPr/>
            <p:nvPr/>
          </p:nvGrpSpPr>
          <p:grpSpPr>
            <a:xfrm>
              <a:off x="243210" y="609244"/>
              <a:ext cx="300082" cy="215444"/>
              <a:chOff x="371399" y="573540"/>
              <a:chExt cx="300082" cy="215444"/>
            </a:xfrm>
          </p:grpSpPr>
          <p:sp>
            <p:nvSpPr>
              <p:cNvPr id="176" name="文本框 175">
                <a:extLst>
                  <a:ext uri="{FF2B5EF4-FFF2-40B4-BE49-F238E27FC236}">
                    <a16:creationId xmlns:a16="http://schemas.microsoft.com/office/drawing/2014/main" id="{9A57EF7B-69C2-4D91-8B83-B5F44F7A372C}"/>
                  </a:ext>
                </a:extLst>
              </p:cNvPr>
              <p:cNvSpPr txBox="1"/>
              <p:nvPr/>
            </p:nvSpPr>
            <p:spPr>
              <a:xfrm>
                <a:off x="371399" y="5735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7" name="直接连接符 176">
                <a:extLst>
                  <a:ext uri="{FF2B5EF4-FFF2-40B4-BE49-F238E27FC236}">
                    <a16:creationId xmlns:a16="http://schemas.microsoft.com/office/drawing/2014/main" id="{2BF67EDE-6F3A-408E-9587-313B77776D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843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2" name="组合 171">
              <a:extLst>
                <a:ext uri="{FF2B5EF4-FFF2-40B4-BE49-F238E27FC236}">
                  <a16:creationId xmlns:a16="http://schemas.microsoft.com/office/drawing/2014/main" id="{471F2241-5770-4C18-9704-D4CE157EB486}"/>
                </a:ext>
              </a:extLst>
            </p:cNvPr>
            <p:cNvGrpSpPr/>
            <p:nvPr/>
          </p:nvGrpSpPr>
          <p:grpSpPr>
            <a:xfrm>
              <a:off x="185502" y="288734"/>
              <a:ext cx="357790" cy="215444"/>
              <a:chOff x="312125" y="459240"/>
              <a:chExt cx="357790" cy="215444"/>
            </a:xfrm>
          </p:grpSpPr>
          <p:sp>
            <p:nvSpPr>
              <p:cNvPr id="174" name="文本框 173">
                <a:extLst>
                  <a:ext uri="{FF2B5EF4-FFF2-40B4-BE49-F238E27FC236}">
                    <a16:creationId xmlns:a16="http://schemas.microsoft.com/office/drawing/2014/main" id="{22A357B1-B005-4C74-98E3-AAEC0C7CC611}"/>
                  </a:ext>
                </a:extLst>
              </p:cNvPr>
              <p:cNvSpPr txBox="1"/>
              <p:nvPr/>
            </p:nvSpPr>
            <p:spPr>
              <a:xfrm>
                <a:off x="312125" y="4592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5" name="直接连接符 174">
                <a:extLst>
                  <a:ext uri="{FF2B5EF4-FFF2-40B4-BE49-F238E27FC236}">
                    <a16:creationId xmlns:a16="http://schemas.microsoft.com/office/drawing/2014/main" id="{79CE47B7-E79A-4CAA-A033-A79320310C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5700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AC2036C8-A4C1-4B72-95EF-83230C95514D}"/>
                </a:ext>
              </a:extLst>
            </p:cNvPr>
            <p:cNvSpPr txBox="1"/>
            <p:nvPr/>
          </p:nvSpPr>
          <p:spPr>
            <a:xfrm>
              <a:off x="191462" y="125046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2" name="矩形 181">
            <a:extLst>
              <a:ext uri="{FF2B5EF4-FFF2-40B4-BE49-F238E27FC236}">
                <a16:creationId xmlns:a16="http://schemas.microsoft.com/office/drawing/2014/main" id="{85C4110A-1720-4C0A-A820-BEB01C7B7D78}"/>
              </a:ext>
            </a:extLst>
          </p:cNvPr>
          <p:cNvSpPr/>
          <p:nvPr/>
        </p:nvSpPr>
        <p:spPr>
          <a:xfrm>
            <a:off x="1995456" y="7678317"/>
            <a:ext cx="402342" cy="175269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09C4B868-CDEE-4870-A828-ACCF869A8EB7}"/>
              </a:ext>
            </a:extLst>
          </p:cNvPr>
          <p:cNvSpPr txBox="1"/>
          <p:nvPr/>
        </p:nvSpPr>
        <p:spPr>
          <a:xfrm>
            <a:off x="2457865" y="7670009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4" name="对象 183">
            <a:extLst>
              <a:ext uri="{FF2B5EF4-FFF2-40B4-BE49-F238E27FC236}">
                <a16:creationId xmlns:a16="http://schemas.microsoft.com/office/drawing/2014/main" id="{34ECE098-AEBC-43F5-8E50-C384A96A19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667708"/>
              </p:ext>
            </p:extLst>
          </p:nvPr>
        </p:nvGraphicFramePr>
        <p:xfrm>
          <a:off x="1940338" y="4972566"/>
          <a:ext cx="558720" cy="1041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10" r:id="rId23" imgW="2793600" imgH="5206320" progId="">
                  <p:embed/>
                </p:oleObj>
              </mc:Choice>
              <mc:Fallback>
                <p:oleObj r:id="rId23" imgW="2793600" imgH="5206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1940338" y="4972566"/>
                        <a:ext cx="558720" cy="1041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85" name="组合 184">
            <a:extLst>
              <a:ext uri="{FF2B5EF4-FFF2-40B4-BE49-F238E27FC236}">
                <a16:creationId xmlns:a16="http://schemas.microsoft.com/office/drawing/2014/main" id="{8106327E-D79C-466E-8494-E139E5375CD9}"/>
              </a:ext>
            </a:extLst>
          </p:cNvPr>
          <p:cNvGrpSpPr/>
          <p:nvPr/>
        </p:nvGrpSpPr>
        <p:grpSpPr>
          <a:xfrm>
            <a:off x="1601133" y="5019180"/>
            <a:ext cx="373368" cy="974328"/>
            <a:chOff x="185502" y="154680"/>
            <a:chExt cx="373368" cy="974328"/>
          </a:xfrm>
        </p:grpSpPr>
        <p:grpSp>
          <p:nvGrpSpPr>
            <p:cNvPr id="186" name="组合 185">
              <a:extLst>
                <a:ext uri="{FF2B5EF4-FFF2-40B4-BE49-F238E27FC236}">
                  <a16:creationId xmlns:a16="http://schemas.microsoft.com/office/drawing/2014/main" id="{D5BEA649-728F-48CF-9E6A-D575A4495F51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197" name="文本框 196">
                <a:extLst>
                  <a:ext uri="{FF2B5EF4-FFF2-40B4-BE49-F238E27FC236}">
                    <a16:creationId xmlns:a16="http://schemas.microsoft.com/office/drawing/2014/main" id="{46CC569F-F933-4082-ADC5-E29E08591CC3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8" name="直接连接符 197">
                <a:extLst>
                  <a:ext uri="{FF2B5EF4-FFF2-40B4-BE49-F238E27FC236}">
                    <a16:creationId xmlns:a16="http://schemas.microsoft.com/office/drawing/2014/main" id="{917B0C1B-2A78-4989-87FB-1D653E9137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7" name="组合 186">
              <a:extLst>
                <a:ext uri="{FF2B5EF4-FFF2-40B4-BE49-F238E27FC236}">
                  <a16:creationId xmlns:a16="http://schemas.microsoft.com/office/drawing/2014/main" id="{6908D4DE-26CA-4346-9BCB-492F794D5594}"/>
                </a:ext>
              </a:extLst>
            </p:cNvPr>
            <p:cNvGrpSpPr/>
            <p:nvPr/>
          </p:nvGrpSpPr>
          <p:grpSpPr>
            <a:xfrm>
              <a:off x="243210" y="754541"/>
              <a:ext cx="300082" cy="215444"/>
              <a:chOff x="371399" y="497340"/>
              <a:chExt cx="300082" cy="215444"/>
            </a:xfrm>
          </p:grpSpPr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A2F5D2B1-9D3E-45AA-8192-0AB94D753B0D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6" name="直接连接符 195">
                <a:extLst>
                  <a:ext uri="{FF2B5EF4-FFF2-40B4-BE49-F238E27FC236}">
                    <a16:creationId xmlns:a16="http://schemas.microsoft.com/office/drawing/2014/main" id="{8B208BA4-B255-4C50-B234-03DAD4F06A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8" name="组合 187">
              <a:extLst>
                <a:ext uri="{FF2B5EF4-FFF2-40B4-BE49-F238E27FC236}">
                  <a16:creationId xmlns:a16="http://schemas.microsoft.com/office/drawing/2014/main" id="{9D763B2D-3D74-4785-BA88-D59959D31009}"/>
                </a:ext>
              </a:extLst>
            </p:cNvPr>
            <p:cNvGrpSpPr/>
            <p:nvPr/>
          </p:nvGrpSpPr>
          <p:grpSpPr>
            <a:xfrm>
              <a:off x="243210" y="533044"/>
              <a:ext cx="300082" cy="215444"/>
              <a:chOff x="371399" y="497340"/>
              <a:chExt cx="300082" cy="215444"/>
            </a:xfrm>
          </p:grpSpPr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D6FB7794-0479-419B-85F4-20E874E92505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4" name="直接连接符 193">
                <a:extLst>
                  <a:ext uri="{FF2B5EF4-FFF2-40B4-BE49-F238E27FC236}">
                    <a16:creationId xmlns:a16="http://schemas.microsoft.com/office/drawing/2014/main" id="{42702D42-801B-49BB-AF42-58707BCC45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9" name="组合 188">
              <a:extLst>
                <a:ext uri="{FF2B5EF4-FFF2-40B4-BE49-F238E27FC236}">
                  <a16:creationId xmlns:a16="http://schemas.microsoft.com/office/drawing/2014/main" id="{BA9BD065-7237-4EEC-A554-F0C678956D1F}"/>
                </a:ext>
              </a:extLst>
            </p:cNvPr>
            <p:cNvGrpSpPr/>
            <p:nvPr/>
          </p:nvGrpSpPr>
          <p:grpSpPr>
            <a:xfrm>
              <a:off x="185502" y="326834"/>
              <a:ext cx="357790" cy="215444"/>
              <a:chOff x="312125" y="497340"/>
              <a:chExt cx="357790" cy="215444"/>
            </a:xfrm>
          </p:grpSpPr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588369FF-F08E-47FA-8A2A-67505A12A6BA}"/>
                  </a:ext>
                </a:extLst>
              </p:cNvPr>
              <p:cNvSpPr txBox="1"/>
              <p:nvPr/>
            </p:nvSpPr>
            <p:spPr>
              <a:xfrm>
                <a:off x="312125" y="49734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2" name="直接连接符 191">
                <a:extLst>
                  <a:ext uri="{FF2B5EF4-FFF2-40B4-BE49-F238E27FC236}">
                    <a16:creationId xmlns:a16="http://schemas.microsoft.com/office/drawing/2014/main" id="{294CC66A-C02B-411B-96D5-500DA8FF4F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DC0482A9-084E-48B5-B160-255076128FFE}"/>
                </a:ext>
              </a:extLst>
            </p:cNvPr>
            <p:cNvSpPr txBox="1"/>
            <p:nvPr/>
          </p:nvSpPr>
          <p:spPr>
            <a:xfrm>
              <a:off x="191462" y="154680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9" name="矩形 198">
            <a:extLst>
              <a:ext uri="{FF2B5EF4-FFF2-40B4-BE49-F238E27FC236}">
                <a16:creationId xmlns:a16="http://schemas.microsoft.com/office/drawing/2014/main" id="{A4BAA80E-5860-4113-AA42-65CFFCB177B8}"/>
              </a:ext>
            </a:extLst>
          </p:cNvPr>
          <p:cNvSpPr/>
          <p:nvPr/>
        </p:nvSpPr>
        <p:spPr>
          <a:xfrm>
            <a:off x="2023077" y="5746850"/>
            <a:ext cx="402342" cy="175269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id="{1600BA42-11C8-42B1-8CC5-2AF8CB695679}"/>
              </a:ext>
            </a:extLst>
          </p:cNvPr>
          <p:cNvSpPr txBox="1"/>
          <p:nvPr/>
        </p:nvSpPr>
        <p:spPr>
          <a:xfrm>
            <a:off x="2452390" y="5734456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1" name="对象 200">
            <a:extLst>
              <a:ext uri="{FF2B5EF4-FFF2-40B4-BE49-F238E27FC236}">
                <a16:creationId xmlns:a16="http://schemas.microsoft.com/office/drawing/2014/main" id="{470E78D5-F2D6-4149-A60A-6E95D145C0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1441439"/>
              </p:ext>
            </p:extLst>
          </p:nvPr>
        </p:nvGraphicFramePr>
        <p:xfrm>
          <a:off x="5014876" y="5028083"/>
          <a:ext cx="502848" cy="9370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11" r:id="rId25" imgW="2514240" imgH="4685400" progId="">
                  <p:embed/>
                </p:oleObj>
              </mc:Choice>
              <mc:Fallback>
                <p:oleObj r:id="rId25" imgW="2514240" imgH="46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>
                        <a:lum bright="-5000"/>
                      </a:blip>
                      <a:stretch>
                        <a:fillRect/>
                      </a:stretch>
                    </p:blipFill>
                    <p:spPr>
                      <a:xfrm>
                        <a:off x="5014876" y="5028083"/>
                        <a:ext cx="502848" cy="9370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2" name="文本框 201">
            <a:extLst>
              <a:ext uri="{FF2B5EF4-FFF2-40B4-BE49-F238E27FC236}">
                <a16:creationId xmlns:a16="http://schemas.microsoft.com/office/drawing/2014/main" id="{044D168C-F7CF-4FA9-A7B4-26B19116B4B0}"/>
              </a:ext>
            </a:extLst>
          </p:cNvPr>
          <p:cNvSpPr txBox="1"/>
          <p:nvPr/>
        </p:nvSpPr>
        <p:spPr>
          <a:xfrm>
            <a:off x="5486397" y="5656652"/>
            <a:ext cx="4555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矩形 202">
            <a:extLst>
              <a:ext uri="{FF2B5EF4-FFF2-40B4-BE49-F238E27FC236}">
                <a16:creationId xmlns:a16="http://schemas.microsoft.com/office/drawing/2014/main" id="{BAB9B469-D057-4C06-B5AF-1B113D6350B0}"/>
              </a:ext>
            </a:extLst>
          </p:cNvPr>
          <p:cNvSpPr/>
          <p:nvPr/>
        </p:nvSpPr>
        <p:spPr>
          <a:xfrm>
            <a:off x="5045953" y="5673691"/>
            <a:ext cx="402342" cy="175269"/>
          </a:xfrm>
          <a:prstGeom prst="rect">
            <a:avLst/>
          </a:prstGeom>
          <a:noFill/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grpSp>
        <p:nvGrpSpPr>
          <p:cNvPr id="218" name="组合 217">
            <a:extLst>
              <a:ext uri="{FF2B5EF4-FFF2-40B4-BE49-F238E27FC236}">
                <a16:creationId xmlns:a16="http://schemas.microsoft.com/office/drawing/2014/main" id="{50B613E3-55B7-4BAC-A6B4-7CD7BE6E0F5A}"/>
              </a:ext>
            </a:extLst>
          </p:cNvPr>
          <p:cNvGrpSpPr/>
          <p:nvPr/>
        </p:nvGrpSpPr>
        <p:grpSpPr>
          <a:xfrm>
            <a:off x="4678740" y="4967995"/>
            <a:ext cx="369135" cy="948929"/>
            <a:chOff x="185502" y="180079"/>
            <a:chExt cx="369135" cy="948929"/>
          </a:xfrm>
        </p:grpSpPr>
        <p:grpSp>
          <p:nvGrpSpPr>
            <p:cNvPr id="219" name="组合 218">
              <a:extLst>
                <a:ext uri="{FF2B5EF4-FFF2-40B4-BE49-F238E27FC236}">
                  <a16:creationId xmlns:a16="http://schemas.microsoft.com/office/drawing/2014/main" id="{79A3E7B4-8218-4988-BBE3-52D364C0EE71}"/>
                </a:ext>
              </a:extLst>
            </p:cNvPr>
            <p:cNvGrpSpPr/>
            <p:nvPr/>
          </p:nvGrpSpPr>
          <p:grpSpPr>
            <a:xfrm>
              <a:off x="243210" y="913564"/>
              <a:ext cx="300082" cy="215444"/>
              <a:chOff x="371399" y="497340"/>
              <a:chExt cx="300082" cy="215444"/>
            </a:xfrm>
          </p:grpSpPr>
          <p:sp>
            <p:nvSpPr>
              <p:cNvPr id="230" name="文本框 229">
                <a:extLst>
                  <a:ext uri="{FF2B5EF4-FFF2-40B4-BE49-F238E27FC236}">
                    <a16:creationId xmlns:a16="http://schemas.microsoft.com/office/drawing/2014/main" id="{67072F3E-9534-4839-BF9C-AA045B6A2762}"/>
                  </a:ext>
                </a:extLst>
              </p:cNvPr>
              <p:cNvSpPr txBox="1"/>
              <p:nvPr/>
            </p:nvSpPr>
            <p:spPr>
              <a:xfrm>
                <a:off x="371399" y="4973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1" name="直接连接符 230">
                <a:extLst>
                  <a:ext uri="{FF2B5EF4-FFF2-40B4-BE49-F238E27FC236}">
                    <a16:creationId xmlns:a16="http://schemas.microsoft.com/office/drawing/2014/main" id="{DB32FD77-0AE8-44C7-864B-628F31587E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08154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0" name="组合 219">
              <a:extLst>
                <a:ext uri="{FF2B5EF4-FFF2-40B4-BE49-F238E27FC236}">
                  <a16:creationId xmlns:a16="http://schemas.microsoft.com/office/drawing/2014/main" id="{B616A611-9EC5-47D8-BA7F-22FBBFF47727}"/>
                </a:ext>
              </a:extLst>
            </p:cNvPr>
            <p:cNvGrpSpPr/>
            <p:nvPr/>
          </p:nvGrpSpPr>
          <p:grpSpPr>
            <a:xfrm>
              <a:off x="243210" y="770416"/>
              <a:ext cx="300082" cy="215444"/>
              <a:chOff x="371399" y="513215"/>
              <a:chExt cx="300082" cy="215444"/>
            </a:xfrm>
          </p:grpSpPr>
          <p:sp>
            <p:nvSpPr>
              <p:cNvPr id="228" name="文本框 227">
                <a:extLst>
                  <a:ext uri="{FF2B5EF4-FFF2-40B4-BE49-F238E27FC236}">
                    <a16:creationId xmlns:a16="http://schemas.microsoft.com/office/drawing/2014/main" id="{B4676AE5-F9B6-4222-94ED-DA376E4B3E66}"/>
                  </a:ext>
                </a:extLst>
              </p:cNvPr>
              <p:cNvSpPr txBox="1"/>
              <p:nvPr/>
            </p:nvSpPr>
            <p:spPr>
              <a:xfrm>
                <a:off x="371399" y="51321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9" name="直接连接符 228">
                <a:extLst>
                  <a:ext uri="{FF2B5EF4-FFF2-40B4-BE49-F238E27FC236}">
                    <a16:creationId xmlns:a16="http://schemas.microsoft.com/office/drawing/2014/main" id="{FAB93325-5133-4570-A0AF-E6376A8FFF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24029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1" name="组合 220">
              <a:extLst>
                <a:ext uri="{FF2B5EF4-FFF2-40B4-BE49-F238E27FC236}">
                  <a16:creationId xmlns:a16="http://schemas.microsoft.com/office/drawing/2014/main" id="{2122E562-4BC6-4B41-9BCC-058F4FF0F418}"/>
                </a:ext>
              </a:extLst>
            </p:cNvPr>
            <p:cNvGrpSpPr/>
            <p:nvPr/>
          </p:nvGrpSpPr>
          <p:grpSpPr>
            <a:xfrm>
              <a:off x="243210" y="561621"/>
              <a:ext cx="300082" cy="215444"/>
              <a:chOff x="371399" y="525917"/>
              <a:chExt cx="300082" cy="215444"/>
            </a:xfrm>
          </p:grpSpPr>
          <p:sp>
            <p:nvSpPr>
              <p:cNvPr id="226" name="文本框 225">
                <a:extLst>
                  <a:ext uri="{FF2B5EF4-FFF2-40B4-BE49-F238E27FC236}">
                    <a16:creationId xmlns:a16="http://schemas.microsoft.com/office/drawing/2014/main" id="{6EAB66E5-93C5-4727-92C7-8FD20418966F}"/>
                  </a:ext>
                </a:extLst>
              </p:cNvPr>
              <p:cNvSpPr txBox="1"/>
              <p:nvPr/>
            </p:nvSpPr>
            <p:spPr>
              <a:xfrm>
                <a:off x="371399" y="52591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7" name="直接连接符 226">
                <a:extLst>
                  <a:ext uri="{FF2B5EF4-FFF2-40B4-BE49-F238E27FC236}">
                    <a16:creationId xmlns:a16="http://schemas.microsoft.com/office/drawing/2014/main" id="{906D5CCA-009A-47A0-B1AB-E41BB22692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6731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2" name="组合 221">
              <a:extLst>
                <a:ext uri="{FF2B5EF4-FFF2-40B4-BE49-F238E27FC236}">
                  <a16:creationId xmlns:a16="http://schemas.microsoft.com/office/drawing/2014/main" id="{95E566E2-0AEA-4B97-A924-55DC39DA085D}"/>
                </a:ext>
              </a:extLst>
            </p:cNvPr>
            <p:cNvGrpSpPr/>
            <p:nvPr/>
          </p:nvGrpSpPr>
          <p:grpSpPr>
            <a:xfrm>
              <a:off x="185502" y="350121"/>
              <a:ext cx="357790" cy="215444"/>
              <a:chOff x="312125" y="520627"/>
              <a:chExt cx="357790" cy="215444"/>
            </a:xfrm>
          </p:grpSpPr>
          <p:sp>
            <p:nvSpPr>
              <p:cNvPr id="224" name="文本框 223">
                <a:extLst>
                  <a:ext uri="{FF2B5EF4-FFF2-40B4-BE49-F238E27FC236}">
                    <a16:creationId xmlns:a16="http://schemas.microsoft.com/office/drawing/2014/main" id="{E1EB706E-EA22-4659-8BBF-0187B9F27E9F}"/>
                  </a:ext>
                </a:extLst>
              </p:cNvPr>
              <p:cNvSpPr txBox="1"/>
              <p:nvPr/>
            </p:nvSpPr>
            <p:spPr>
              <a:xfrm>
                <a:off x="312125" y="520627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5" name="直接连接符 224">
                <a:extLst>
                  <a:ext uri="{FF2B5EF4-FFF2-40B4-BE49-F238E27FC236}">
                    <a16:creationId xmlns:a16="http://schemas.microsoft.com/office/drawing/2014/main" id="{3B8ECB2B-4564-4201-87FF-2D210918D7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156" y="631441"/>
                <a:ext cx="66425" cy="0"/>
              </a:xfrm>
              <a:prstGeom prst="line">
                <a:avLst/>
              </a:prstGeom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3" name="文本框 222">
              <a:extLst>
                <a:ext uri="{FF2B5EF4-FFF2-40B4-BE49-F238E27FC236}">
                  <a16:creationId xmlns:a16="http://schemas.microsoft.com/office/drawing/2014/main" id="{37F82CD8-38FC-428D-8696-A12AAE05C2E8}"/>
                </a:ext>
              </a:extLst>
            </p:cNvPr>
            <p:cNvSpPr txBox="1"/>
            <p:nvPr/>
          </p:nvSpPr>
          <p:spPr>
            <a:xfrm>
              <a:off x="187229" y="18007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39B77318-EB46-4C02-B8BF-D211509E3E0A}"/>
              </a:ext>
            </a:extLst>
          </p:cNvPr>
          <p:cNvSpPr/>
          <p:nvPr/>
        </p:nvSpPr>
        <p:spPr>
          <a:xfrm>
            <a:off x="126586" y="862402"/>
            <a:ext cx="4523672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矩形: 圆角 213">
            <a:extLst>
              <a:ext uri="{FF2B5EF4-FFF2-40B4-BE49-F238E27FC236}">
                <a16:creationId xmlns:a16="http://schemas.microsoft.com/office/drawing/2014/main" id="{AC3276D3-89DB-4621-8FE7-CECCC132C32B}"/>
              </a:ext>
            </a:extLst>
          </p:cNvPr>
          <p:cNvSpPr/>
          <p:nvPr/>
        </p:nvSpPr>
        <p:spPr>
          <a:xfrm>
            <a:off x="126586" y="2810878"/>
            <a:ext cx="2804979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矩形: 圆角 214">
            <a:extLst>
              <a:ext uri="{FF2B5EF4-FFF2-40B4-BE49-F238E27FC236}">
                <a16:creationId xmlns:a16="http://schemas.microsoft.com/office/drawing/2014/main" id="{BF5E8FB8-80A7-4B7C-B459-15487BA8501B}"/>
              </a:ext>
            </a:extLst>
          </p:cNvPr>
          <p:cNvSpPr/>
          <p:nvPr/>
        </p:nvSpPr>
        <p:spPr>
          <a:xfrm>
            <a:off x="3190544" y="2810878"/>
            <a:ext cx="2804979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" name="矩形: 圆角 215">
            <a:extLst>
              <a:ext uri="{FF2B5EF4-FFF2-40B4-BE49-F238E27FC236}">
                <a16:creationId xmlns:a16="http://schemas.microsoft.com/office/drawing/2014/main" id="{A6793E9B-0164-4CD6-9A6D-C5E4D650C27E}"/>
              </a:ext>
            </a:extLst>
          </p:cNvPr>
          <p:cNvSpPr/>
          <p:nvPr/>
        </p:nvSpPr>
        <p:spPr>
          <a:xfrm>
            <a:off x="126586" y="4759354"/>
            <a:ext cx="2804979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7" name="矩形: 圆角 216">
            <a:extLst>
              <a:ext uri="{FF2B5EF4-FFF2-40B4-BE49-F238E27FC236}">
                <a16:creationId xmlns:a16="http://schemas.microsoft.com/office/drawing/2014/main" id="{60011BE1-8000-4DD7-A52B-7BA465A142EC}"/>
              </a:ext>
            </a:extLst>
          </p:cNvPr>
          <p:cNvSpPr/>
          <p:nvPr/>
        </p:nvSpPr>
        <p:spPr>
          <a:xfrm>
            <a:off x="3190544" y="4759354"/>
            <a:ext cx="2804979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矩形: 圆角 231">
            <a:extLst>
              <a:ext uri="{FF2B5EF4-FFF2-40B4-BE49-F238E27FC236}">
                <a16:creationId xmlns:a16="http://schemas.microsoft.com/office/drawing/2014/main" id="{32D1E0D5-8AC6-46FE-86B2-CE8DE2A2C113}"/>
              </a:ext>
            </a:extLst>
          </p:cNvPr>
          <p:cNvSpPr/>
          <p:nvPr/>
        </p:nvSpPr>
        <p:spPr>
          <a:xfrm>
            <a:off x="126586" y="6707830"/>
            <a:ext cx="2804979" cy="1651088"/>
          </a:xfrm>
          <a:prstGeom prst="roundRect">
            <a:avLst/>
          </a:prstGeom>
          <a:noFill/>
          <a:ln w="952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92F12F1-7A15-4205-8976-75682FE47002}"/>
              </a:ext>
            </a:extLst>
          </p:cNvPr>
          <p:cNvSpPr txBox="1"/>
          <p:nvPr/>
        </p:nvSpPr>
        <p:spPr>
          <a:xfrm>
            <a:off x="1830241" y="306426"/>
            <a:ext cx="2459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cropped images for Western blots</a:t>
            </a:r>
          </a:p>
        </p:txBody>
      </p:sp>
    </p:spTree>
    <p:extLst>
      <p:ext uri="{BB962C8B-B14F-4D97-AF65-F5344CB8AC3E}">
        <p14:creationId xmlns:p14="http://schemas.microsoft.com/office/powerpoint/2010/main" val="899319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24</TotalTime>
  <Words>89</Words>
  <Application>Microsoft Office PowerPoint</Application>
  <PresentationFormat>自定义</PresentationFormat>
  <Paragraphs>79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海萍</dc:creator>
  <cp:lastModifiedBy>Duanwu Zhang</cp:lastModifiedBy>
  <cp:revision>321</cp:revision>
  <cp:lastPrinted>2024-10-16T04:42:11Z</cp:lastPrinted>
  <dcterms:created xsi:type="dcterms:W3CDTF">2024-02-28T12:31:51Z</dcterms:created>
  <dcterms:modified xsi:type="dcterms:W3CDTF">2024-10-16T04:43:04Z</dcterms:modified>
</cp:coreProperties>
</file>